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77" r:id="rId2"/>
  </p:sldIdLst>
  <p:sldSz cx="6858000" cy="9906000" type="A4"/>
  <p:notesSz cx="6797675" cy="9926638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143" userDrawn="1">
          <p15:clr>
            <a:srgbClr val="A4A3A4"/>
          </p15:clr>
        </p15:guide>
        <p15:guide id="2" pos="2183" userDrawn="1">
          <p15:clr>
            <a:srgbClr val="A4A3A4"/>
          </p15:clr>
        </p15:guide>
      </p15:sldGuideLst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go="http://customooxmlschemas.google.com/" r:id="rId16" roundtripDataSignature="AMtx7mh/0X9QH/tCkpYSgFALJwZJ61agrA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820" autoAdjust="0"/>
    <p:restoredTop sz="96370" autoAdjust="0"/>
  </p:normalViewPr>
  <p:slideViewPr>
    <p:cSldViewPr snapToGrid="0" snapToObjects="1" showGuides="1">
      <p:cViewPr varScale="1">
        <p:scale>
          <a:sx n="51" d="100"/>
          <a:sy n="51" d="100"/>
        </p:scale>
        <p:origin x="2316" y="72"/>
      </p:cViewPr>
      <p:guideLst>
        <p:guide orient="horz" pos="3143"/>
        <p:guide pos="218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8" Type="http://schemas.openxmlformats.org/officeDocument/2006/relationships/viewProps" Target="viewProps.xml"/><Relationship Id="rId3" Type="http://schemas.openxmlformats.org/officeDocument/2006/relationships/notesMaster" Target="notesMasters/notesMaster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customschemas.google.com/relationships/presentationmetadata" Target="metadata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1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4538"/>
            <a:ext cx="2574925" cy="3722687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79768" y="4715130"/>
            <a:ext cx="5438140" cy="44669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979" tIns="90979" rIns="90979" bIns="90979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2248433761"/>
      </p:ext>
    </p:extLst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15"/>
          <p:cNvSpPr txBox="1"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15"/>
          <p:cNvSpPr txBox="1"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9pPr>
          </a:lstStyle>
          <a:p>
            <a:endParaRPr/>
          </a:p>
        </p:txBody>
      </p:sp>
      <p:sp>
        <p:nvSpPr>
          <p:cNvPr id="23" name="Google Shape;23;p15"/>
          <p:cNvSpPr txBox="1">
            <a:spLocks noGrp="1"/>
          </p:cNvSpPr>
          <p:nvPr>
            <p:ph type="dt" idx="10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15"/>
          <p:cNvSpPr txBox="1">
            <a:spLocks noGrp="1"/>
          </p:cNvSpPr>
          <p:nvPr>
            <p:ph type="ftr" idx="11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15"/>
          <p:cNvSpPr txBox="1">
            <a:spLocks noGrp="1"/>
          </p:cNvSpPr>
          <p:nvPr>
            <p:ph type="sldNum" idx="12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17"/>
          <p:cNvSpPr txBox="1"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17"/>
          <p:cNvSpPr txBox="1"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181" lvl="0" indent="-228591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361" lvl="1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543" lvl="2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724" lvl="3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5904" lvl="4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085" lvl="5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266" lvl="6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447" lvl="7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628" lvl="8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5" name="Google Shape;35;p17"/>
          <p:cNvSpPr txBox="1">
            <a:spLocks noGrp="1"/>
          </p:cNvSpPr>
          <p:nvPr>
            <p:ph type="dt" idx="10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17"/>
          <p:cNvSpPr txBox="1">
            <a:spLocks noGrp="1"/>
          </p:cNvSpPr>
          <p:nvPr>
            <p:ph type="ftr" idx="11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7" name="Google Shape;37;p17"/>
          <p:cNvSpPr txBox="1">
            <a:spLocks noGrp="1"/>
          </p:cNvSpPr>
          <p:nvPr>
            <p:ph type="sldNum" idx="12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Google Shape;39;p18"/>
          <p:cNvSpPr txBox="1"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0" name="Google Shape;40;p18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181" lvl="0" indent="-342886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361" lvl="1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543" lvl="2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724" lvl="3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5904" lvl="4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085" lvl="5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266" lvl="6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447" lvl="7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628" lvl="8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18"/>
          <p:cNvSpPr txBox="1">
            <a:spLocks noGrp="1"/>
          </p:cNvSpPr>
          <p:nvPr>
            <p:ph type="body" idx="2"/>
          </p:nvPr>
        </p:nvSpPr>
        <p:spPr>
          <a:xfrm>
            <a:off x="3471863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181" lvl="0" indent="-342886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361" lvl="1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543" lvl="2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724" lvl="3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5904" lvl="4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085" lvl="5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266" lvl="6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447" lvl="7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628" lvl="8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18"/>
          <p:cNvSpPr txBox="1">
            <a:spLocks noGrp="1"/>
          </p:cNvSpPr>
          <p:nvPr>
            <p:ph type="dt" idx="10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18"/>
          <p:cNvSpPr txBox="1">
            <a:spLocks noGrp="1"/>
          </p:cNvSpPr>
          <p:nvPr>
            <p:ph type="ftr" idx="11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18"/>
          <p:cNvSpPr txBox="1">
            <a:spLocks noGrp="1"/>
          </p:cNvSpPr>
          <p:nvPr>
            <p:ph type="sldNum" idx="12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19"/>
          <p:cNvSpPr txBox="1"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9"/>
          <p:cNvSpPr txBox="1"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181" lvl="0" indent="-228591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361" lvl="1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543" lvl="2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724" lvl="3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5904" lvl="4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085" lvl="5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266" lvl="6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447" lvl="7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628" lvl="8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8" name="Google Shape;48;p19"/>
          <p:cNvSpPr txBox="1">
            <a:spLocks noGrp="1"/>
          </p:cNvSpPr>
          <p:nvPr>
            <p:ph type="body" idx="2"/>
          </p:nvPr>
        </p:nvSpPr>
        <p:spPr>
          <a:xfrm>
            <a:off x="472382" y="3618443"/>
            <a:ext cx="2901255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181" lvl="0" indent="-342886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361" lvl="1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543" lvl="2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724" lvl="3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5904" lvl="4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085" lvl="5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266" lvl="6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447" lvl="7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628" lvl="8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9" name="Google Shape;49;p19"/>
          <p:cNvSpPr txBox="1">
            <a:spLocks noGrp="1"/>
          </p:cNvSpPr>
          <p:nvPr>
            <p:ph type="body" idx="3"/>
          </p:nvPr>
        </p:nvSpPr>
        <p:spPr>
          <a:xfrm>
            <a:off x="3471864" y="2428348"/>
            <a:ext cx="2915543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181" lvl="0" indent="-228591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361" lvl="1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543" lvl="2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724" lvl="3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5904" lvl="4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085" lvl="5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266" lvl="6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447" lvl="7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628" lvl="8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50" name="Google Shape;50;p19"/>
          <p:cNvSpPr txBox="1">
            <a:spLocks noGrp="1"/>
          </p:cNvSpPr>
          <p:nvPr>
            <p:ph type="body" idx="4"/>
          </p:nvPr>
        </p:nvSpPr>
        <p:spPr>
          <a:xfrm>
            <a:off x="3471864" y="3618443"/>
            <a:ext cx="2915543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181" lvl="0" indent="-342886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361" lvl="1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543" lvl="2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724" lvl="3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5904" lvl="4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085" lvl="5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266" lvl="6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447" lvl="7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628" lvl="8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1" name="Google Shape;51;p19"/>
          <p:cNvSpPr txBox="1">
            <a:spLocks noGrp="1"/>
          </p:cNvSpPr>
          <p:nvPr>
            <p:ph type="dt" idx="10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9"/>
          <p:cNvSpPr txBox="1">
            <a:spLocks noGrp="1"/>
          </p:cNvSpPr>
          <p:nvPr>
            <p:ph type="ftr" idx="11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9"/>
          <p:cNvSpPr txBox="1">
            <a:spLocks noGrp="1"/>
          </p:cNvSpPr>
          <p:nvPr>
            <p:ph type="sldNum" idx="12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20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20"/>
          <p:cNvSpPr txBox="1">
            <a:spLocks noGrp="1"/>
          </p:cNvSpPr>
          <p:nvPr>
            <p:ph type="body" idx="1"/>
          </p:nvPr>
        </p:nvSpPr>
        <p:spPr>
          <a:xfrm>
            <a:off x="2915544" y="1426284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181" lvl="0" indent="-380984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361" lvl="1" indent="-36193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543" lvl="2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724" lvl="3" indent="-32383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5904" lvl="4" indent="-32383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085" lvl="5" indent="-32383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266" lvl="6" indent="-32383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447" lvl="7" indent="-32383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628" lvl="8" indent="-32383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57" name="Google Shape;57;p20"/>
          <p:cNvSpPr txBox="1">
            <a:spLocks noGrp="1"/>
          </p:cNvSpPr>
          <p:nvPr>
            <p:ph type="body" idx="2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181" lvl="0" indent="-228591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361" lvl="1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543" lvl="2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724" lvl="3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5904" lvl="4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085" lvl="5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266" lvl="6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447" lvl="7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628" lvl="8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8" name="Google Shape;58;p20"/>
          <p:cNvSpPr txBox="1">
            <a:spLocks noGrp="1"/>
          </p:cNvSpPr>
          <p:nvPr>
            <p:ph type="dt" idx="10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20"/>
          <p:cNvSpPr txBox="1">
            <a:spLocks noGrp="1"/>
          </p:cNvSpPr>
          <p:nvPr>
            <p:ph type="ftr" idx="11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20"/>
          <p:cNvSpPr txBox="1">
            <a:spLocks noGrp="1"/>
          </p:cNvSpPr>
          <p:nvPr>
            <p:ph type="sldNum" idx="12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21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21"/>
          <p:cNvSpPr>
            <a:spLocks noGrp="1"/>
          </p:cNvSpPr>
          <p:nvPr>
            <p:ph type="pic" idx="2"/>
          </p:nvPr>
        </p:nvSpPr>
        <p:spPr>
          <a:xfrm>
            <a:off x="2915544" y="1426284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None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4" name="Google Shape;64;p21"/>
          <p:cNvSpPr txBox="1">
            <a:spLocks noGrp="1"/>
          </p:cNvSpPr>
          <p:nvPr>
            <p:ph type="body" idx="1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181" lvl="0" indent="-228591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361" lvl="1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543" lvl="2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724" lvl="3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5904" lvl="4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085" lvl="5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266" lvl="6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447" lvl="7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628" lvl="8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5" name="Google Shape;65;p21"/>
          <p:cNvSpPr txBox="1">
            <a:spLocks noGrp="1"/>
          </p:cNvSpPr>
          <p:nvPr>
            <p:ph type="dt" idx="10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21"/>
          <p:cNvSpPr txBox="1">
            <a:spLocks noGrp="1"/>
          </p:cNvSpPr>
          <p:nvPr>
            <p:ph type="ftr" idx="11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21"/>
          <p:cNvSpPr txBox="1">
            <a:spLocks noGrp="1"/>
          </p:cNvSpPr>
          <p:nvPr>
            <p:ph type="sldNum" idx="12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22"/>
          <p:cNvSpPr txBox="1"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2"/>
          <p:cNvSpPr txBox="1">
            <a:spLocks noGrp="1"/>
          </p:cNvSpPr>
          <p:nvPr>
            <p:ph type="body" idx="1"/>
          </p:nvPr>
        </p:nvSpPr>
        <p:spPr>
          <a:xfrm rot="5400000">
            <a:off x="286367" y="2822136"/>
            <a:ext cx="6285266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181" lvl="0" indent="-342886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361" lvl="1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543" lvl="2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724" lvl="3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5904" lvl="4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085" lvl="5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266" lvl="6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447" lvl="7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628" lvl="8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22"/>
          <p:cNvSpPr txBox="1">
            <a:spLocks noGrp="1"/>
          </p:cNvSpPr>
          <p:nvPr>
            <p:ph type="dt" idx="10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22"/>
          <p:cNvSpPr txBox="1">
            <a:spLocks noGrp="1"/>
          </p:cNvSpPr>
          <p:nvPr>
            <p:ph type="ftr" idx="11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22"/>
          <p:cNvSpPr txBox="1">
            <a:spLocks noGrp="1"/>
          </p:cNvSpPr>
          <p:nvPr>
            <p:ph type="sldNum" idx="12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23"/>
          <p:cNvSpPr txBox="1">
            <a:spLocks noGrp="1"/>
          </p:cNvSpPr>
          <p:nvPr>
            <p:ph type="title"/>
          </p:nvPr>
        </p:nvSpPr>
        <p:spPr>
          <a:xfrm rot="5400000">
            <a:off x="1449697" y="3985465"/>
            <a:ext cx="839487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23"/>
          <p:cNvSpPr txBox="1">
            <a:spLocks noGrp="1"/>
          </p:cNvSpPr>
          <p:nvPr>
            <p:ph type="body" idx="1"/>
          </p:nvPr>
        </p:nvSpPr>
        <p:spPr>
          <a:xfrm rot="5400000">
            <a:off x="-1550678" y="2549571"/>
            <a:ext cx="839487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181" lvl="0" indent="-342886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361" lvl="1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543" lvl="2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724" lvl="3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5904" lvl="4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085" lvl="5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266" lvl="6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447" lvl="7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628" lvl="8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23"/>
          <p:cNvSpPr txBox="1">
            <a:spLocks noGrp="1"/>
          </p:cNvSpPr>
          <p:nvPr>
            <p:ph type="dt" idx="10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23"/>
          <p:cNvSpPr txBox="1">
            <a:spLocks noGrp="1"/>
          </p:cNvSpPr>
          <p:nvPr>
            <p:ph type="ftr" idx="11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23"/>
          <p:cNvSpPr txBox="1">
            <a:spLocks noGrp="1"/>
          </p:cNvSpPr>
          <p:nvPr>
            <p:ph type="sldNum" idx="12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9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2"/>
          <p:cNvSpPr txBox="1"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12"/>
          <p:cNvSpPr txBox="1"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12"/>
          <p:cNvSpPr txBox="1">
            <a:spLocks noGrp="1"/>
          </p:cNvSpPr>
          <p:nvPr>
            <p:ph type="dt" idx="10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12"/>
          <p:cNvSpPr txBox="1">
            <a:spLocks noGrp="1"/>
          </p:cNvSpPr>
          <p:nvPr>
            <p:ph type="ftr" idx="11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12"/>
          <p:cNvSpPr txBox="1">
            <a:spLocks noGrp="1"/>
          </p:cNvSpPr>
          <p:nvPr>
            <p:ph type="sldNum" idx="12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1" r:id="rId1"/>
    <p:sldLayoutId id="2147483653" r:id="rId2"/>
    <p:sldLayoutId id="2147483654" r:id="rId3"/>
    <p:sldLayoutId id="2147483655" r:id="rId4"/>
    <p:sldLayoutId id="2147483656" r:id="rId5"/>
    <p:sldLayoutId id="2147483657" r:id="rId6"/>
    <p:sldLayoutId id="2147483658" r:id="rId7"/>
    <p:sldLayoutId id="2147483659" r:id="rId8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788DE8D3-1BAF-4C68-B5E1-599C684026C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8113015"/>
              </p:ext>
            </p:extLst>
          </p:nvPr>
        </p:nvGraphicFramePr>
        <p:xfrm>
          <a:off x="57150" y="652598"/>
          <a:ext cx="6753228" cy="5954676"/>
        </p:xfrm>
        <a:graphic>
          <a:graphicData uri="http://schemas.openxmlformats.org/drawingml/2006/table">
            <a:tbl>
              <a:tblPr/>
              <a:tblGrid>
                <a:gridCol w="3359335">
                  <a:extLst>
                    <a:ext uri="{9D8B030D-6E8A-4147-A177-3AD203B41FA5}">
                      <a16:colId xmlns:a16="http://schemas.microsoft.com/office/drawing/2014/main" val="3536899222"/>
                    </a:ext>
                  </a:extLst>
                </a:gridCol>
                <a:gridCol w="407820">
                  <a:extLst>
                    <a:ext uri="{9D8B030D-6E8A-4147-A177-3AD203B41FA5}">
                      <a16:colId xmlns:a16="http://schemas.microsoft.com/office/drawing/2014/main" val="413525433"/>
                    </a:ext>
                  </a:extLst>
                </a:gridCol>
                <a:gridCol w="407820">
                  <a:extLst>
                    <a:ext uri="{9D8B030D-6E8A-4147-A177-3AD203B41FA5}">
                      <a16:colId xmlns:a16="http://schemas.microsoft.com/office/drawing/2014/main" val="2435068537"/>
                    </a:ext>
                  </a:extLst>
                </a:gridCol>
                <a:gridCol w="407820">
                  <a:extLst>
                    <a:ext uri="{9D8B030D-6E8A-4147-A177-3AD203B41FA5}">
                      <a16:colId xmlns:a16="http://schemas.microsoft.com/office/drawing/2014/main" val="2695699399"/>
                    </a:ext>
                  </a:extLst>
                </a:gridCol>
                <a:gridCol w="407820">
                  <a:extLst>
                    <a:ext uri="{9D8B030D-6E8A-4147-A177-3AD203B41FA5}">
                      <a16:colId xmlns:a16="http://schemas.microsoft.com/office/drawing/2014/main" val="1947968760"/>
                    </a:ext>
                  </a:extLst>
                </a:gridCol>
                <a:gridCol w="407820">
                  <a:extLst>
                    <a:ext uri="{9D8B030D-6E8A-4147-A177-3AD203B41FA5}">
                      <a16:colId xmlns:a16="http://schemas.microsoft.com/office/drawing/2014/main" val="3507117668"/>
                    </a:ext>
                  </a:extLst>
                </a:gridCol>
                <a:gridCol w="407820">
                  <a:extLst>
                    <a:ext uri="{9D8B030D-6E8A-4147-A177-3AD203B41FA5}">
                      <a16:colId xmlns:a16="http://schemas.microsoft.com/office/drawing/2014/main" val="3637811469"/>
                    </a:ext>
                  </a:extLst>
                </a:gridCol>
                <a:gridCol w="407820">
                  <a:extLst>
                    <a:ext uri="{9D8B030D-6E8A-4147-A177-3AD203B41FA5}">
                      <a16:colId xmlns:a16="http://schemas.microsoft.com/office/drawing/2014/main" val="1453902128"/>
                    </a:ext>
                  </a:extLst>
                </a:gridCol>
                <a:gridCol w="539153">
                  <a:extLst>
                    <a:ext uri="{9D8B030D-6E8A-4147-A177-3AD203B41FA5}">
                      <a16:colId xmlns:a16="http://schemas.microsoft.com/office/drawing/2014/main" val="909348439"/>
                    </a:ext>
                  </a:extLst>
                </a:gridCol>
              </a:tblGrid>
              <a:tr h="24155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anonical_Pathways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P63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1" u="none" strike="noStrike" spc="-100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TXBP4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KDR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P53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D274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1" u="none" strike="noStrike" spc="-100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UBB3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1" u="none" strike="noStrike" spc="-100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TMN1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spc="-100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|STXBP4|</a:t>
                      </a:r>
                    </a:p>
                    <a:p>
                      <a:pPr algn="ctr" fontAlgn="ctr"/>
                      <a:r>
                        <a:rPr lang="en-US" sz="1000" b="1" i="0" u="none" strike="noStrike" spc="-100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&gt;=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8424049"/>
                  </a:ext>
                </a:extLst>
              </a:tr>
              <a:tr h="1229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EIF2_Signaling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.025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8F9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.099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717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53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7B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2.887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BFE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34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EE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37752718"/>
                  </a:ext>
                </a:extLst>
              </a:tr>
              <a:tr h="1229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ignaling_by_Rho_Family_GTPases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286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3A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207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5A7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807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B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2.887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BFE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0.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F7F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0.229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F7F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12523100"/>
                  </a:ext>
                </a:extLst>
              </a:tr>
              <a:tr h="1229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hospholipase_C_Signaling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6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6B8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051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9A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55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DE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3.207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BB8DD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0.775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4EBF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0.845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AF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0.775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4EBF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49466"/>
                  </a:ext>
                </a:extLst>
              </a:tr>
              <a:tr h="1229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Ephrin_Receptor_Signaling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96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09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BAD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414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6D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D1E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D1E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0.898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1E9F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0.728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6ECF7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28789813"/>
                  </a:ext>
                </a:extLst>
              </a:tr>
              <a:tr h="1229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gulation_of_Actin-based_Motility_by_Rho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357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1A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828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FB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121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3C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.633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D9ED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0.63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9EEF8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.414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1DEF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D1E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207203"/>
                  </a:ext>
                </a:extLst>
              </a:tr>
              <a:tr h="1229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L-8_Signaling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71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79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673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4B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667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FD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2.333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5CAE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0.853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9F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0.707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6EDF7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.5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EDCE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01060961"/>
                  </a:ext>
                </a:extLst>
              </a:tr>
              <a:tr h="1229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GF_Signaling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357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1A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646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4B7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1E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.508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EDCE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2.268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7CCE7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.213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7E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88042128"/>
                  </a:ext>
                </a:extLst>
              </a:tr>
              <a:tr h="1229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XCR4_Signaling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84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FB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53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7B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414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6D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D1E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3.051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0BBD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.941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1D2E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56543116"/>
                  </a:ext>
                </a:extLst>
              </a:tr>
              <a:tr h="1229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ntegrin_Signaling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858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EB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53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7B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667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FD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.34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3DFF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0.655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EEF8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3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1BCD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.706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8D7E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44655814"/>
                  </a:ext>
                </a:extLst>
              </a:tr>
              <a:tr h="1229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TOR_Signaling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84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FB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53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7B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89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9C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D1E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.069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BE5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61095541"/>
                  </a:ext>
                </a:extLst>
              </a:tr>
              <a:tr h="1229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hrombin_Signaling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858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EB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53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7B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414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6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.213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7E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0.19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F7F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0.535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F0F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1177956"/>
                  </a:ext>
                </a:extLst>
              </a:tr>
              <a:tr h="1229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F-</a:t>
                      </a:r>
                      <a:r>
                        <a:rPr lang="el-GR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κ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B_Signaling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711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B2B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309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DC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816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6E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3.317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8B5D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.73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8D7E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3.536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1B1D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.807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5E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93689"/>
                  </a:ext>
                </a:extLst>
              </a:tr>
              <a:tr h="1229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uperpathway_of_Inositol_Phosphate_Compounds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34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8D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309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DC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83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6E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2.121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CCFE8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493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F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0.447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F2F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02152598"/>
                  </a:ext>
                </a:extLst>
              </a:tr>
              <a:tr h="1229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ctin_Nucleation_by_ARP-WASP_Complex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714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B2B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236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FC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449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AB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0.333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4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2.646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CC4E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2.236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8CCE7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5889291"/>
                  </a:ext>
                </a:extLst>
              </a:tr>
              <a:tr h="1229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icotine_Degradation_II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236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FC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4.583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B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8338363"/>
                  </a:ext>
                </a:extLst>
              </a:tr>
              <a:tr h="1229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Fcγ_Receptor-mediated_Phagocytosis_in_Macrophages_and_Monocytes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317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2A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236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FC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DE6F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.89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3D4E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2.714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AC2E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229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6F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333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3F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4201274"/>
                  </a:ext>
                </a:extLst>
              </a:tr>
              <a:tr h="1229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itric_Oxide_Signaling_in_the_Cardiovascular_System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309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DC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236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FC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1E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2.449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2C8E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.134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4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229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6F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8128068"/>
                  </a:ext>
                </a:extLst>
              </a:tr>
              <a:tr h="1229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Opioid_Signaling_Pathway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43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3E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138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2C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75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7E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.147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3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.606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BDAE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0.295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3F5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426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5328461"/>
                  </a:ext>
                </a:extLst>
              </a:tr>
              <a:tr h="1229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ynaptogenesis_Signaling_Pathway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667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4B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13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2C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5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8B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3.317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8B5D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.414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1DEF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0.729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6ECF7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90015859"/>
                  </a:ext>
                </a:extLst>
              </a:tr>
              <a:tr h="1229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Oxidative_Phosphorylation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.385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121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3C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D1E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3.96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5A8D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16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6A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6C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12047379"/>
                  </a:ext>
                </a:extLst>
              </a:tr>
              <a:tr h="1229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ctin_Cytoskeleton_Signaling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.264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888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121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3C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138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2C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3.464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4B2D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0.535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F0F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.976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D2E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2.236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8CCE7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00052705"/>
                  </a:ext>
                </a:extLst>
              </a:tr>
              <a:tr h="1229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Glioma_Invasiveness_Signaling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111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3C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6C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34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8D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.265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6E1F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.89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3D4E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93553927"/>
                  </a:ext>
                </a:extLst>
              </a:tr>
              <a:tr h="1229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uperpathway_of_Melatonin_Degradation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6C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6C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4.69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F98CD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447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0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DE6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48429754"/>
                  </a:ext>
                </a:extLst>
              </a:tr>
              <a:tr h="1229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elatonin_Degradation_I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6C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4.69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F98CD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DE6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2806513"/>
                  </a:ext>
                </a:extLst>
              </a:tr>
              <a:tr h="1229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icotine_Degradation_III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6C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4.243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CA2D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4365858"/>
                  </a:ext>
                </a:extLst>
              </a:tr>
              <a:tr h="1229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hoA_Signaling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886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9C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6C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07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9E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.633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D9ED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0.905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E8F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0.277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3F6F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14557315"/>
                  </a:ext>
                </a:extLst>
              </a:tr>
              <a:tr h="1229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Ovarian_Cancer_Signaling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714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B2B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6C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2.236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8CCE7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.89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3D4E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.213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7E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0.905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E8F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8112283"/>
                  </a:ext>
                </a:extLst>
              </a:tr>
              <a:tr h="1229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G_Beta_Gamma_Signaling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828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FB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6C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3.464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4B2D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.667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9D8ED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209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7F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7641442"/>
                  </a:ext>
                </a:extLst>
              </a:tr>
              <a:tr h="1229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F-</a:t>
                      </a:r>
                      <a:r>
                        <a:rPr lang="el-GR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κ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B_Activation_by_Viruses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53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7B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6C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1E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667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FD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0.5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F1F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0.378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F4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7526411"/>
                  </a:ext>
                </a:extLst>
              </a:tr>
              <a:tr h="1229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VEGF_Family_Ligand-Receptor_Interactions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BAD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6C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447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0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0.5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F1F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0.378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F4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6339159"/>
                  </a:ext>
                </a:extLst>
              </a:tr>
              <a:tr h="1229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IF-mediated_Glucocorticoid_Regulation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121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3C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6C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447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0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8049694"/>
                  </a:ext>
                </a:extLst>
              </a:tr>
              <a:tr h="1229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L-9_Signaling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646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4B7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6C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447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0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37178078"/>
                  </a:ext>
                </a:extLst>
              </a:tr>
              <a:tr h="1229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FLT3_Signaling_in_Hematopoietic_Progenitor_Cells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53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7B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6C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0.378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F4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0.943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FE8F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30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4F7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1491872"/>
                  </a:ext>
                </a:extLst>
              </a:tr>
              <a:tr h="1229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GM-CSF_Signaling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496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8B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6C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.414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1DEF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0.535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F0F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4993178"/>
                  </a:ext>
                </a:extLst>
              </a:tr>
              <a:tr h="1229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hoGDI_Signaling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3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1BCD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2.828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7C0E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.667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9D8ED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53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7B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0.243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6F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0.243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6F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577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DF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4541" marR="4541" marT="45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68135064"/>
                  </a:ext>
                </a:extLst>
              </a:tr>
            </a:tbl>
          </a:graphicData>
        </a:graphic>
      </p:graphicFrame>
      <p:sp>
        <p:nvSpPr>
          <p:cNvPr id="6" name="Google Shape;84;p1">
            <a:extLst>
              <a:ext uri="{FF2B5EF4-FFF2-40B4-BE49-F238E27FC236}">
                <a16:creationId xmlns:a16="http://schemas.microsoft.com/office/drawing/2014/main" id="{62175E80-AC79-4992-8D24-D6146FAC8B48}"/>
              </a:ext>
            </a:extLst>
          </p:cNvPr>
          <p:cNvSpPr txBox="1"/>
          <p:nvPr/>
        </p:nvSpPr>
        <p:spPr>
          <a:xfrm>
            <a:off x="0" y="0"/>
            <a:ext cx="4038600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r>
              <a:rPr lang="en-US" altLang="ja-JP" sz="18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Additional</a:t>
            </a:r>
            <a:r>
              <a:rPr lang="ja-JP" altLang="en-US" sz="18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 </a:t>
            </a:r>
            <a:r>
              <a:rPr lang="en-US" altLang="ja-JP" sz="1800" b="1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file 9</a:t>
            </a:r>
            <a:r>
              <a:rPr lang="en-US" sz="1800" b="1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.</a:t>
            </a:r>
            <a:endParaRPr lang="en-US" sz="1800" b="1" dirty="0">
              <a:solidFill>
                <a:schemeClr val="dk1"/>
              </a:solidFill>
              <a:latin typeface="Times New Roman" panose="02020603050405020304" pitchFamily="18" charset="0"/>
              <a:ea typeface="Calibri"/>
              <a:cs typeface="Times New Roman" panose="02020603050405020304" pitchFamily="18" charset="0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4259622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889</TotalTime>
  <Words>556</Words>
  <Application>Microsoft Office PowerPoint</Application>
  <PresentationFormat>A4 210 x 297 mm</PresentationFormat>
  <Paragraphs>29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Bilguun Erkhem-Ochir</dc:creator>
  <cp:lastModifiedBy>西山 正彦</cp:lastModifiedBy>
  <cp:revision>83</cp:revision>
  <cp:lastPrinted>2020-04-09T02:54:04Z</cp:lastPrinted>
  <dcterms:created xsi:type="dcterms:W3CDTF">2018-05-17T03:09:07Z</dcterms:created>
  <dcterms:modified xsi:type="dcterms:W3CDTF">2020-09-06T06:13:34Z</dcterms:modified>
</cp:coreProperties>
</file>